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ilu Guan" initials="DG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8" d="100"/>
          <a:sy n="118" d="100"/>
        </p:scale>
        <p:origin x="-148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01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672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168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466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015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979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520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647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551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19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220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6596C-EEFD-4CF6-A532-87C190CD8778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1137CD-395D-45FE-95C5-954DA02A60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938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857" y="243343"/>
            <a:ext cx="4330035" cy="433003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2362" y="4835549"/>
            <a:ext cx="88978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4: Figure S2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depicting the overlaps of differentially expressed genes between pair-wise T1 v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2, T1 vs. T3 and T2 vs. T3 comparisons. T1 and T2 represent early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8.25 ± 9.29 days after parturition) and late (216.25 ± 9.29 days)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ctation</a:t>
            </a:r>
            <a:r>
              <a:rPr lang="en-US" altLang="zh-CN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,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le T3 (285.25 </a:t>
            </a:r>
            <a:r>
              <a:rPr lang="en-US" altLang="zh-CN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± </a:t>
            </a:r>
            <a:r>
              <a:rPr lang="en-US" altLang="zh-CN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29 days)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s to the dry period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7729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72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ilu Guan</dc:creator>
  <cp:lastModifiedBy>ma</cp:lastModifiedBy>
  <cp:revision>18</cp:revision>
  <dcterms:created xsi:type="dcterms:W3CDTF">2019-08-02T16:07:01Z</dcterms:created>
  <dcterms:modified xsi:type="dcterms:W3CDTF">2020-01-16T18:12:45Z</dcterms:modified>
</cp:coreProperties>
</file>